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6" d="100"/>
          <a:sy n="126" d="100"/>
        </p:scale>
        <p:origin x="-1290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16478F-C676-4543-8DB0-0382F53D51B7}" type="datetimeFigureOut">
              <a:rPr lang="en-US" smtClean="0"/>
              <a:t>8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82CE8-7FA4-4375-B0BB-F94AA7441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42457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16478F-C676-4543-8DB0-0382F53D51B7}" type="datetimeFigureOut">
              <a:rPr lang="en-US" smtClean="0"/>
              <a:t>8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82CE8-7FA4-4375-B0BB-F94AA7441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98993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16478F-C676-4543-8DB0-0382F53D51B7}" type="datetimeFigureOut">
              <a:rPr lang="en-US" smtClean="0"/>
              <a:t>8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82CE8-7FA4-4375-B0BB-F94AA7441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8226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16478F-C676-4543-8DB0-0382F53D51B7}" type="datetimeFigureOut">
              <a:rPr lang="en-US" smtClean="0"/>
              <a:t>8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82CE8-7FA4-4375-B0BB-F94AA7441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02445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16478F-C676-4543-8DB0-0382F53D51B7}" type="datetimeFigureOut">
              <a:rPr lang="en-US" smtClean="0"/>
              <a:t>8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82CE8-7FA4-4375-B0BB-F94AA7441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59735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16478F-C676-4543-8DB0-0382F53D51B7}" type="datetimeFigureOut">
              <a:rPr lang="en-US" smtClean="0"/>
              <a:t>8/1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82CE8-7FA4-4375-B0BB-F94AA7441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25512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16478F-C676-4543-8DB0-0382F53D51B7}" type="datetimeFigureOut">
              <a:rPr lang="en-US" smtClean="0"/>
              <a:t>8/10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82CE8-7FA4-4375-B0BB-F94AA7441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18952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16478F-C676-4543-8DB0-0382F53D51B7}" type="datetimeFigureOut">
              <a:rPr lang="en-US" smtClean="0"/>
              <a:t>8/10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82CE8-7FA4-4375-B0BB-F94AA7441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24942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16478F-C676-4543-8DB0-0382F53D51B7}" type="datetimeFigureOut">
              <a:rPr lang="en-US" smtClean="0"/>
              <a:t>8/10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82CE8-7FA4-4375-B0BB-F94AA7441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86229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16478F-C676-4543-8DB0-0382F53D51B7}" type="datetimeFigureOut">
              <a:rPr lang="en-US" smtClean="0"/>
              <a:t>8/1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82CE8-7FA4-4375-B0BB-F94AA7441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72055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16478F-C676-4543-8DB0-0382F53D51B7}" type="datetimeFigureOut">
              <a:rPr lang="en-US" smtClean="0"/>
              <a:t>8/1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82CE8-7FA4-4375-B0BB-F94AA7441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97437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16478F-C676-4543-8DB0-0382F53D51B7}" type="datetimeFigureOut">
              <a:rPr lang="en-US" smtClean="0"/>
              <a:t>8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182CE8-7FA4-4375-B0BB-F94AA7441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58823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81000" y="152400"/>
            <a:ext cx="8534400" cy="5943600"/>
          </a:xfrm>
          <a:prstGeom prst="rect">
            <a:avLst/>
          </a:prstGeom>
          <a:noFill/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46" name="Group 45"/>
          <p:cNvGrpSpPr/>
          <p:nvPr/>
        </p:nvGrpSpPr>
        <p:grpSpPr>
          <a:xfrm>
            <a:off x="457200" y="228600"/>
            <a:ext cx="8382000" cy="5814476"/>
            <a:chOff x="457200" y="228600"/>
            <a:chExt cx="8382000" cy="5814476"/>
          </a:xfrm>
        </p:grpSpPr>
        <p:pic>
          <p:nvPicPr>
            <p:cNvPr id="5" name="Picture 4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684" t="30076" r="70043" b="44222"/>
            <a:stretch/>
          </p:blipFill>
          <p:spPr bwMode="auto">
            <a:xfrm>
              <a:off x="4724400" y="516466"/>
              <a:ext cx="745967" cy="159806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864" t="31596" r="70172" b="43527"/>
            <a:stretch/>
          </p:blipFill>
          <p:spPr bwMode="auto">
            <a:xfrm>
              <a:off x="533400" y="4091552"/>
              <a:ext cx="723544" cy="154678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684" t="31019" r="70133" b="55191"/>
            <a:stretch/>
          </p:blipFill>
          <p:spPr bwMode="auto">
            <a:xfrm>
              <a:off x="4572000" y="4057684"/>
              <a:ext cx="739416" cy="85739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" name="Picture 4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561" t="25766" r="57479" b="32910"/>
            <a:stretch/>
          </p:blipFill>
          <p:spPr bwMode="auto">
            <a:xfrm>
              <a:off x="1524000" y="491068"/>
              <a:ext cx="795867" cy="256943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" name="Picture 4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871" t="31754" r="46052" b="40603"/>
            <a:stretch/>
          </p:blipFill>
          <p:spPr bwMode="auto">
            <a:xfrm>
              <a:off x="2396067" y="533400"/>
              <a:ext cx="804333" cy="171873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" name="Picture 4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298" t="31479" r="36024" b="40603"/>
            <a:stretch/>
          </p:blipFill>
          <p:spPr bwMode="auto">
            <a:xfrm>
              <a:off x="3183467" y="516466"/>
              <a:ext cx="702733" cy="17358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" name="Picture 4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442" t="31479" r="24015" b="29165"/>
            <a:stretch/>
          </p:blipFill>
          <p:spPr bwMode="auto">
            <a:xfrm>
              <a:off x="3886200" y="516466"/>
              <a:ext cx="838200" cy="24470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" name="Picture 11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664" t="31054" r="58627" b="38570"/>
            <a:stretch/>
          </p:blipFill>
          <p:spPr bwMode="auto">
            <a:xfrm>
              <a:off x="5470733" y="524933"/>
              <a:ext cx="777667" cy="18886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3" name="Picture 1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001" t="31604" r="46044" b="39784"/>
            <a:stretch/>
          </p:blipFill>
          <p:spPr bwMode="auto">
            <a:xfrm>
              <a:off x="6294690" y="524933"/>
              <a:ext cx="868110" cy="17789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4" name="Picture 13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437" t="31615" r="35123" b="47733"/>
            <a:stretch/>
          </p:blipFill>
          <p:spPr bwMode="auto">
            <a:xfrm>
              <a:off x="7166717" y="524933"/>
              <a:ext cx="758083" cy="12840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5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130" t="31063" r="60192" b="38550"/>
            <a:stretch/>
          </p:blipFill>
          <p:spPr bwMode="auto">
            <a:xfrm>
              <a:off x="1295400" y="4057684"/>
              <a:ext cx="702733" cy="188934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6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217" t="31063" r="49515" b="45160"/>
            <a:stretch/>
          </p:blipFill>
          <p:spPr bwMode="auto">
            <a:xfrm>
              <a:off x="2133600" y="4057684"/>
              <a:ext cx="745621" cy="147842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7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053" t="31063" r="38445" b="45160"/>
            <a:stretch/>
          </p:blipFill>
          <p:spPr bwMode="auto">
            <a:xfrm>
              <a:off x="2971800" y="4066151"/>
              <a:ext cx="762530" cy="147842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8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671" t="31063" r="28884" b="47610"/>
            <a:stretch/>
          </p:blipFill>
          <p:spPr bwMode="auto">
            <a:xfrm>
              <a:off x="3810000" y="4057766"/>
              <a:ext cx="685800" cy="132602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9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119" t="31361" r="59554" b="56544"/>
            <a:stretch/>
          </p:blipFill>
          <p:spPr bwMode="auto">
            <a:xfrm>
              <a:off x="5410200" y="4074618"/>
              <a:ext cx="749893" cy="75203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153" t="31360" r="48883" b="41013"/>
            <a:stretch/>
          </p:blipFill>
          <p:spPr bwMode="auto">
            <a:xfrm>
              <a:off x="6248400" y="4083085"/>
              <a:ext cx="723544" cy="171770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1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039" t="31361" r="37962" b="36980"/>
            <a:stretch/>
          </p:blipFill>
          <p:spPr bwMode="auto">
            <a:xfrm>
              <a:off x="7049925" y="4074618"/>
              <a:ext cx="798675" cy="196845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2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038" t="31361" r="26963" b="43762"/>
            <a:stretch/>
          </p:blipFill>
          <p:spPr bwMode="auto">
            <a:xfrm>
              <a:off x="7924800" y="4083085"/>
              <a:ext cx="798676" cy="154678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3" name="Picture 2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875" t="31564" r="69090" b="18367"/>
            <a:stretch/>
          </p:blipFill>
          <p:spPr bwMode="auto">
            <a:xfrm>
              <a:off x="457200" y="381000"/>
              <a:ext cx="1066800" cy="330176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4" name="Picture 3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807" t="31618" r="71720" b="19161"/>
            <a:stretch/>
          </p:blipFill>
          <p:spPr bwMode="auto">
            <a:xfrm>
              <a:off x="8001000" y="400030"/>
              <a:ext cx="838200" cy="317924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5" name="TextBox 24"/>
            <p:cNvSpPr txBox="1"/>
            <p:nvPr/>
          </p:nvSpPr>
          <p:spPr>
            <a:xfrm>
              <a:off x="558801" y="2286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G 1</a:t>
              </a:r>
              <a:endParaRPr lang="en-US" sz="900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600200" y="2286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G 2</a:t>
              </a:r>
              <a:endParaRPr lang="en-US" sz="900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455334" y="2286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G 3</a:t>
              </a:r>
              <a:endParaRPr lang="en-US" sz="900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234265" y="2286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G 4</a:t>
              </a:r>
              <a:endParaRPr lang="en-US" sz="900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979334" y="2286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G 5</a:t>
              </a:r>
              <a:endParaRPr lang="en-US" sz="900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4766732" y="2286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G 6</a:t>
              </a:r>
              <a:endParaRPr lang="en-US" sz="900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5528735" y="2286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G 7</a:t>
              </a:r>
              <a:endParaRPr lang="en-US" sz="900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6324600" y="2286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G 8</a:t>
              </a:r>
              <a:endParaRPr lang="en-US" sz="900" dirty="0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7196665" y="2286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G 9</a:t>
              </a:r>
              <a:endParaRPr lang="en-US" sz="900" dirty="0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8043335" y="2286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G 10</a:t>
              </a:r>
              <a:endParaRPr lang="en-US" sz="900" dirty="0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558801" y="38862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G 11</a:t>
              </a:r>
              <a:endParaRPr lang="en-US" sz="900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1329265" y="38862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G 12</a:t>
              </a:r>
              <a:endParaRPr lang="en-US" sz="900" dirty="0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2167468" y="38862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G 13</a:t>
              </a:r>
              <a:endParaRPr lang="en-US" sz="900" dirty="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005665" y="38862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G 14</a:t>
              </a:r>
              <a:endParaRPr lang="en-US" sz="900" dirty="0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3826934" y="38862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G 15</a:t>
              </a:r>
              <a:endParaRPr lang="en-US" sz="900" dirty="0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4572000" y="38862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G 16</a:t>
              </a:r>
              <a:endParaRPr lang="en-US" sz="900" dirty="0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5410200" y="38862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G 17</a:t>
              </a:r>
              <a:endParaRPr lang="en-US" sz="900" dirty="0"/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6248400" y="38862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G 18</a:t>
              </a:r>
              <a:endParaRPr lang="en-US" sz="900" dirty="0"/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7086600" y="38862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G 19</a:t>
              </a:r>
              <a:endParaRPr lang="en-US" sz="900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7924800" y="38862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/>
                <a:t>LG 20</a:t>
              </a:r>
              <a:endParaRPr lang="en-US" sz="900" dirty="0"/>
            </a:p>
          </p:txBody>
        </p:sp>
      </p:grpSp>
      <p:sp>
        <p:nvSpPr>
          <p:cNvPr id="45" name="TextBox 44"/>
          <p:cNvSpPr txBox="1"/>
          <p:nvPr/>
        </p:nvSpPr>
        <p:spPr>
          <a:xfrm>
            <a:off x="381000" y="6172200"/>
            <a:ext cx="8610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Figure 3. Construction of genetic linkage map in the F</a:t>
            </a:r>
            <a:r>
              <a:rPr lang="en-US" sz="1200" baseline="-25000" dirty="0"/>
              <a:t>2</a:t>
            </a:r>
            <a:r>
              <a:rPr lang="en-US" sz="1200" dirty="0"/>
              <a:t> population derived from the cross </a:t>
            </a:r>
            <a:r>
              <a:rPr lang="en-US" sz="1200" dirty="0" smtClean="0"/>
              <a:t>between two </a:t>
            </a:r>
            <a:r>
              <a:rPr lang="en-US" sz="1200" smtClean="0"/>
              <a:t>peanut cultivars </a:t>
            </a:r>
            <a:r>
              <a:rPr lang="en-US" sz="1200" dirty="0" smtClean="0"/>
              <a:t>‘</a:t>
            </a:r>
            <a:r>
              <a:rPr lang="en-US" sz="1200" dirty="0" err="1" smtClean="0"/>
              <a:t>Yueyou</a:t>
            </a:r>
            <a:r>
              <a:rPr lang="en-US" sz="1200" dirty="0" smtClean="0"/>
              <a:t> </a:t>
            </a:r>
            <a:r>
              <a:rPr lang="en-US" sz="1200" dirty="0"/>
              <a:t>92’ and ‘</a:t>
            </a:r>
            <a:r>
              <a:rPr lang="en-US" sz="1200" dirty="0" err="1"/>
              <a:t>Xinhuixiaoli</a:t>
            </a:r>
            <a:r>
              <a:rPr lang="en-US" sz="1200" dirty="0"/>
              <a:t>’. </a:t>
            </a:r>
            <a:r>
              <a:rPr lang="en-US" sz="1200" dirty="0" smtClean="0"/>
              <a:t>Two </a:t>
            </a:r>
            <a:r>
              <a:rPr lang="en-US" sz="1200" dirty="0"/>
              <a:t>hundred </a:t>
            </a:r>
            <a:r>
              <a:rPr lang="en-US" sz="1200" dirty="0" smtClean="0"/>
              <a:t>thirty seven </a:t>
            </a:r>
            <a:r>
              <a:rPr lang="en-US" sz="1200" dirty="0"/>
              <a:t>SSR and SNP markers were mapped, covering </a:t>
            </a:r>
            <a:r>
              <a:rPr lang="en-US" sz="1200" dirty="0" smtClean="0"/>
              <a:t>1,627.4 </a:t>
            </a:r>
            <a:r>
              <a:rPr lang="en-US" sz="1200" dirty="0" err="1"/>
              <a:t>cM</a:t>
            </a:r>
            <a:r>
              <a:rPr lang="en-US" sz="1200" dirty="0" err="1" smtClean="0"/>
              <a:t>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095362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</TotalTime>
  <Words>83</Words>
  <Application>Microsoft Office PowerPoint</Application>
  <PresentationFormat>On-screen Show 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</dc:creator>
  <cp:lastModifiedBy>admin</cp:lastModifiedBy>
  <cp:revision>6</cp:revision>
  <dcterms:created xsi:type="dcterms:W3CDTF">2015-03-11T20:25:36Z</dcterms:created>
  <dcterms:modified xsi:type="dcterms:W3CDTF">2015-08-10T21:01:21Z</dcterms:modified>
</cp:coreProperties>
</file>